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8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-54"/>
      </p:cViewPr>
      <p:guideLst>
        <p:guide orient="horz" pos="31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7965BD-FD03-4C8F-A197-EC50D7697508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BED53-BBA4-43C4-9D66-9DCD9637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7183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61343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1" y="39673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3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1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1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25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25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94" y="2217387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94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25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12" y="39443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25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SHIVAP~1\AppData\Local\Temp\ATH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1" y="1765140"/>
            <a:ext cx="3124200" cy="5557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900600" y="999188"/>
            <a:ext cx="4038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argeting of AGO3 mRNA by miR403 is not a conserved phenomen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02525" y="1460856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h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GO3 targeted by at-miR403</a:t>
            </a:r>
            <a:endParaRPr lang="en-IN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3" descr="C:\Users\SHIVAP~1\AppData\Local\Temp\ALY - a,b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1064" y="2890417"/>
            <a:ext cx="3133737" cy="5360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00600" y="2509413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y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GO3 targeted by al-miR403</a:t>
            </a:r>
            <a:endParaRPr lang="en-IN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27028" y="264702"/>
            <a:ext cx="2667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0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676400" y="3886200"/>
            <a:ext cx="2577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10. </a:t>
            </a:r>
            <a:r>
              <a:rPr lang="en-US" sz="1200" dirty="0" smtClean="0"/>
              <a:t>Ago3 targeting by miR403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24316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79</TotalTime>
  <Words>31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124</cp:revision>
  <dcterms:created xsi:type="dcterms:W3CDTF">2006-08-16T00:00:00Z</dcterms:created>
  <dcterms:modified xsi:type="dcterms:W3CDTF">2014-08-25T07:46:51Z</dcterms:modified>
</cp:coreProperties>
</file>